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6A44BE-607E-153B-D0D5-554C5C79E4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A8AEF0-0DD1-E1A4-8666-DDCFCAFDCE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5AECE8-CDC1-9D63-6165-6749CE124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794A87-0757-626E-5B71-751B17F85E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1CAD96-D745-0AB3-8D2A-8E5F7C6E3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922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A96318-1E88-0D89-DBCE-E2D80AF677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2420AD-64C9-C87C-5E0D-F63C5CEDE5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95CA45-21AF-2456-E699-BD5E73935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7FAC6D-3BA0-84CB-642E-0874A937D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60D04A-82C8-8C07-16B7-99DDB90F9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776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656966-5FC6-7E0A-10AA-AAC80A35A6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8FC439-3D05-333C-D8CD-76F8530758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F31DB1-2BE1-FC17-58E4-73A96A3DB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CA723-2015-F457-72EB-331106058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821269-33F7-B276-0E05-2DC308AF5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659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AC87C0-4531-BC9B-A930-C88474239B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2660E8-01B1-4C84-52A1-DE9A4520A1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04AE39-F261-8405-E242-7F9569488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FAB843-916D-75BE-DBB2-E9EC022180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B116F-6019-D2D8-9642-CB6D2A29C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2563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590095-95F5-030E-FA2F-72301A2743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A45475-0FEE-4850-F9D8-7E760B3119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4FB268-28F8-C3D8-BEB4-88B0E0160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EC750E-A09F-5BAA-4364-A297DF0DA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90A24A-1C68-255D-C691-512B6FC10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686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8F2C12-5628-FA5E-CD09-92004DE5BF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E05AFD-3CB7-54FA-2AE7-8E3938033C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27B6B6-8F45-7A5B-CB3C-8FD68D7EB8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608010-8035-C0E7-6B71-BDEB9D932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2408C7-C79E-879C-684B-910A03392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005FEB-90CE-D522-0552-020B34D6D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1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17779C-0393-C4BD-F8E3-0456C4573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AC3559-C01A-BCB2-1F2B-9131636681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08A8D2-4337-AFEE-6D55-AEEB3343AE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A1763F4-B610-1052-7D00-DA696744F2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64E8D9-E876-F0B2-016C-A0AC79E1D4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D4285D9-2AB7-B4E3-C10F-794E476616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7A3FBE-FDBB-C5D7-74B9-D67E31730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F5A817-41FD-E358-DB67-A7B49DE045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238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3E25AA-0BFA-1565-AD4C-F77ADC8F2B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A5B6B0-98A4-18BE-4A3C-9EE4A08F0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86BF979-9BCC-16CD-E159-2D7A24F53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130A67-CF43-F487-963C-E1B5ADEA6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623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A2402E-0738-1101-7AA6-2E31875AB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0ED482-8396-49AB-B8AD-8E09F30D8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F46C69-AF6D-8D70-B403-38FD58927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024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FD6742-7442-A3CF-FB35-6735F4FA20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FFE6FC-1522-9869-D176-7719210E6D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8D090B-CB78-7239-71D0-DCE5838720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736BC2-ED56-8FBE-C249-8FEB77D5C7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BB1D91-13F6-6A31-A68F-7230F2512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A7D2A8-91A7-A660-FCFF-66D272D0A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772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D06A80-C85B-BCB6-5CE2-8A99D29A05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14D8434-7705-BF76-0086-F3DBED9A30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4D1BE5-5000-A965-8888-2EA494084C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F237E7-F6EA-A4BE-D916-2C209B6F4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F77136-F772-0F42-3AD1-4A664D9DF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D78F6E-610A-5A5A-3800-BF5A7FBC9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217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31A580-E7A7-1191-69FA-740D262EA1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D4A672-DE4D-0796-EF3A-DAC9FC3E00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4248CA-42C2-3CF2-0749-B184FEB31E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DE6D35-F479-CA49-93DB-D05C8E6B327F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B1DCEE-6530-6B8F-C47E-EC2761C5C0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5A05A1-B38C-3391-FE8E-D1CBCDBDF2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2CD91-F4BA-244C-8AEE-D7A4C87B4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811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B1ECA1A1-420E-F7A1-9EB4-A09E6AF706B8}"/>
              </a:ext>
            </a:extLst>
          </p:cNvPr>
          <p:cNvGrpSpPr/>
          <p:nvPr/>
        </p:nvGrpSpPr>
        <p:grpSpPr>
          <a:xfrm>
            <a:off x="9170041" y="72104"/>
            <a:ext cx="2622550" cy="6081354"/>
            <a:chOff x="6069500" y="72104"/>
            <a:chExt cx="2622550" cy="6081354"/>
          </a:xfrm>
        </p:grpSpPr>
        <p:pic>
          <p:nvPicPr>
            <p:cNvPr id="5" name="Picture 4" descr="A picture containing dark, night sky&#10;&#10;Description automatically generated">
              <a:extLst>
                <a:ext uri="{FF2B5EF4-FFF2-40B4-BE49-F238E27FC236}">
                  <a16:creationId xmlns:a16="http://schemas.microsoft.com/office/drawing/2014/main" id="{38C93C01-E09A-933D-5E50-100007DCEEE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69500" y="441436"/>
              <a:ext cx="2485379" cy="1986455"/>
            </a:xfrm>
            <a:prstGeom prst="rect">
              <a:avLst/>
            </a:prstGeom>
          </p:spPr>
        </p:pic>
        <p:pic>
          <p:nvPicPr>
            <p:cNvPr id="7" name="Picture 6" descr="A picture containing text, oven, kitchen appliance&#10;&#10;Description automatically generated">
              <a:extLst>
                <a:ext uri="{FF2B5EF4-FFF2-40B4-BE49-F238E27FC236}">
                  <a16:creationId xmlns:a16="http://schemas.microsoft.com/office/drawing/2014/main" id="{65E128CE-38D7-9348-5747-8DB1ADCEE8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69500" y="2427891"/>
              <a:ext cx="2622550" cy="2096090"/>
            </a:xfrm>
            <a:prstGeom prst="rect">
              <a:avLst/>
            </a:prstGeom>
          </p:spPr>
        </p:pic>
        <p:pic>
          <p:nvPicPr>
            <p:cNvPr id="9" name="Picture 8" descr="A picture containing text, monitor, indoor, clock&#10;&#10;Description automatically generated">
              <a:extLst>
                <a:ext uri="{FF2B5EF4-FFF2-40B4-BE49-F238E27FC236}">
                  <a16:creationId xmlns:a16="http://schemas.microsoft.com/office/drawing/2014/main" id="{3D012DDD-5642-C362-4F30-82111D42E57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69500" y="4057368"/>
              <a:ext cx="2622550" cy="209609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5586601-5F76-9835-D3DB-30291C46A509}"/>
                </a:ext>
              </a:extLst>
            </p:cNvPr>
            <p:cNvSpPr txBox="1"/>
            <p:nvPr/>
          </p:nvSpPr>
          <p:spPr>
            <a:xfrm>
              <a:off x="6597891" y="72104"/>
              <a:ext cx="14285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nti-G6PDH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A3311836-BF24-989C-735E-450869EEECE0}"/>
              </a:ext>
            </a:extLst>
          </p:cNvPr>
          <p:cNvSpPr txBox="1"/>
          <p:nvPr/>
        </p:nvSpPr>
        <p:spPr>
          <a:xfrm>
            <a:off x="3943973" y="1106452"/>
            <a:ext cx="226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hemiluminesc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F4C2F14-1BA5-F3BC-F06E-521089E2C545}"/>
              </a:ext>
            </a:extLst>
          </p:cNvPr>
          <p:cNvSpPr txBox="1"/>
          <p:nvPr/>
        </p:nvSpPr>
        <p:spPr>
          <a:xfrm>
            <a:off x="4627144" y="2918515"/>
            <a:ext cx="14029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lorimetri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D4592FB-A197-E63F-AE2B-B61A182953C2}"/>
              </a:ext>
            </a:extLst>
          </p:cNvPr>
          <p:cNvSpPr txBox="1"/>
          <p:nvPr/>
        </p:nvSpPr>
        <p:spPr>
          <a:xfrm>
            <a:off x="4627144" y="4646498"/>
            <a:ext cx="14029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mposit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DEAEA67-24F2-424C-C892-62111489D8C7}"/>
              </a:ext>
            </a:extLst>
          </p:cNvPr>
          <p:cNvGrpSpPr/>
          <p:nvPr/>
        </p:nvGrpSpPr>
        <p:grpSpPr>
          <a:xfrm>
            <a:off x="6177486" y="72104"/>
            <a:ext cx="2633060" cy="6079383"/>
            <a:chOff x="9561807" y="72104"/>
            <a:chExt cx="2633060" cy="6079383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085DD1D-78B9-4669-F1A1-DF7532E6022D}"/>
                </a:ext>
              </a:extLst>
            </p:cNvPr>
            <p:cNvSpPr txBox="1"/>
            <p:nvPr/>
          </p:nvSpPr>
          <p:spPr>
            <a:xfrm>
              <a:off x="10194492" y="72104"/>
              <a:ext cx="189239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Picture 18" descr="A light in the dark&#10;&#10;Description automatically generated with low confidence">
              <a:extLst>
                <a:ext uri="{FF2B5EF4-FFF2-40B4-BE49-F238E27FC236}">
                  <a16:creationId xmlns:a16="http://schemas.microsoft.com/office/drawing/2014/main" id="{0F6E2EBE-DA9A-9064-61FD-02B8036C2CA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592550" y="441436"/>
              <a:ext cx="2494341" cy="1993618"/>
            </a:xfrm>
            <a:prstGeom prst="rect">
              <a:avLst/>
            </a:prstGeom>
          </p:spPr>
        </p:pic>
        <p:pic>
          <p:nvPicPr>
            <p:cNvPr id="21" name="Picture 20" descr="A picture containing text, white, microwave, kitchen appliance&#10;&#10;Description automatically generated">
              <a:extLst>
                <a:ext uri="{FF2B5EF4-FFF2-40B4-BE49-F238E27FC236}">
                  <a16:creationId xmlns:a16="http://schemas.microsoft.com/office/drawing/2014/main" id="{8146EB78-F899-625F-13BA-3301E336E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572317" y="2396320"/>
              <a:ext cx="2622550" cy="2096090"/>
            </a:xfrm>
            <a:prstGeom prst="rect">
              <a:avLst/>
            </a:prstGeom>
          </p:spPr>
        </p:pic>
        <p:pic>
          <p:nvPicPr>
            <p:cNvPr id="23" name="Picture 22" descr="A picture containing text, monitor, indoor, screen&#10;&#10;Description automatically generated">
              <a:extLst>
                <a:ext uri="{FF2B5EF4-FFF2-40B4-BE49-F238E27FC236}">
                  <a16:creationId xmlns:a16="http://schemas.microsoft.com/office/drawing/2014/main" id="{3C581159-BBA1-4CC6-9721-C59B03E663F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561807" y="4055397"/>
              <a:ext cx="2622550" cy="209609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924774AC-7A25-F314-78E4-65A79F5D1259}"/>
              </a:ext>
            </a:extLst>
          </p:cNvPr>
          <p:cNvSpPr txBox="1"/>
          <p:nvPr/>
        </p:nvSpPr>
        <p:spPr>
          <a:xfrm>
            <a:off x="11359721" y="6550223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3 Dat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4797DA1-018A-A6CD-0DAE-AEEF9D2A38BA}"/>
              </a:ext>
            </a:extLst>
          </p:cNvPr>
          <p:cNvSpPr txBox="1"/>
          <p:nvPr/>
        </p:nvSpPr>
        <p:spPr>
          <a:xfrm>
            <a:off x="945933" y="4360335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3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86A5ABA-3DF4-B198-AA57-5D436E34614B}"/>
              </a:ext>
            </a:extLst>
          </p:cNvPr>
          <p:cNvSpPr txBox="1"/>
          <p:nvPr/>
        </p:nvSpPr>
        <p:spPr>
          <a:xfrm>
            <a:off x="0" y="72104"/>
            <a:ext cx="3111576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3 Data. Underlying data for Fig 3C. 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emiluminescence (</a:t>
            </a:r>
            <a:r>
              <a:rPr lang="en-US" sz="1600" dirty="0">
                <a:effectLst/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</a:t>
            </a:r>
            <a:r>
              <a:rPr lang="en-US" sz="16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</a:t>
            </a:r>
            <a:r>
              <a:rPr lang="en-US" sz="16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yc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ignal) and colorimetric (molecular weight standard) data are presented, as well as a composite image.</a:t>
            </a:r>
            <a:r>
              <a:rPr lang="en-US" sz="16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A picture containing table&#10;&#10;Description automatically generated">
            <a:extLst>
              <a:ext uri="{FF2B5EF4-FFF2-40B4-BE49-F238E27FC236}">
                <a16:creationId xmlns:a16="http://schemas.microsoft.com/office/drawing/2014/main" id="{8BDBDCCE-140C-9975-BA09-D6A3C755525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0038" t="12103" r="26256" b="24707"/>
          <a:stretch/>
        </p:blipFill>
        <p:spPr>
          <a:xfrm>
            <a:off x="191078" y="2466135"/>
            <a:ext cx="2920498" cy="193292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5E97E5BD-AEE9-2D0F-7C8B-555C1BFF0476}"/>
              </a:ext>
            </a:extLst>
          </p:cNvPr>
          <p:cNvSpPr txBox="1"/>
          <p:nvPr/>
        </p:nvSpPr>
        <p:spPr>
          <a:xfrm>
            <a:off x="476084" y="2666190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4174099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2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 Alani</dc:creator>
  <cp:lastModifiedBy>Eric Alani</cp:lastModifiedBy>
  <cp:revision>7</cp:revision>
  <cp:lastPrinted>2023-02-05T15:13:53Z</cp:lastPrinted>
  <dcterms:created xsi:type="dcterms:W3CDTF">2022-11-28T20:55:31Z</dcterms:created>
  <dcterms:modified xsi:type="dcterms:W3CDTF">2023-03-27T13:26:48Z</dcterms:modified>
</cp:coreProperties>
</file>